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32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1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885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94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483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667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543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750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224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815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471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E8563-8F94-4190-A87A-B51D2CD4CD97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569F8-F431-45D1-8EFD-6AC7748B1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518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89" r="54215" b="11317"/>
          <a:stretch/>
        </p:blipFill>
        <p:spPr>
          <a:xfrm>
            <a:off x="726186" y="164591"/>
            <a:ext cx="2140063" cy="24231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359" r="55042" b="10803"/>
          <a:stretch/>
        </p:blipFill>
        <p:spPr>
          <a:xfrm>
            <a:off x="3154373" y="201166"/>
            <a:ext cx="2101381" cy="241401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60" t="15449" b="14658"/>
          <a:stretch/>
        </p:blipFill>
        <p:spPr>
          <a:xfrm>
            <a:off x="5759958" y="164591"/>
            <a:ext cx="2413701" cy="248716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487" y="2771466"/>
            <a:ext cx="5033772" cy="355854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677863" y="850392"/>
            <a:ext cx="157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7 (d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759958" y="4324505"/>
            <a:ext cx="157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7 (c)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693652" y="6366583"/>
            <a:ext cx="9080740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 Fig. Uncropped western blots shown in Fig 7 of the manuscript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Blots were probed with anti-Act B and anti-His tag Antibodies. Molecular Mass Marker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vex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arp Pre-stained Protei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ndards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6450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9</TotalTime>
  <Words>4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zzaro, Candice L</dc:creator>
  <cp:lastModifiedBy>Billings, Paul C</cp:lastModifiedBy>
  <cp:revision>3</cp:revision>
  <dcterms:created xsi:type="dcterms:W3CDTF">2020-01-30T21:14:01Z</dcterms:created>
  <dcterms:modified xsi:type="dcterms:W3CDTF">2020-01-31T13:44:46Z</dcterms:modified>
</cp:coreProperties>
</file>